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0058400" cy="7772400"/>
  <p:notesSz cx="6858000" cy="9144000"/>
  <p:defaultTextStyle>
    <a:defPPr>
      <a:defRPr lang="en-US"/>
    </a:defPPr>
    <a:lvl1pPr marL="0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58" d="100"/>
          <a:sy n="58" d="100"/>
        </p:scale>
        <p:origin x="1356" y="60"/>
      </p:cViewPr>
      <p:guideLst>
        <p:guide orient="horz" pos="244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nshumansingh\Documents\anshuman1\fwdsfqtl\10APR\22J_2014WSSFQTLMappingExpTMDOT_WORKBOOK_2_9APR(SingleSite_1434939372206)\STRES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359580052493447E-2"/>
          <c:y val="3.7008398950131235E-2"/>
          <c:w val="0.52569496747689148"/>
          <c:h val="0.87948608923884519"/>
        </c:manualLayout>
      </c:layout>
      <c:scatterChart>
        <c:scatterStyle val="lineMarker"/>
        <c:varyColors val="0"/>
        <c:ser>
          <c:idx val="1"/>
          <c:order val="1"/>
          <c:tx>
            <c:strRef>
              <c:f>Sheet3!$AD$1</c:f>
              <c:strCache>
                <c:ptCount val="1"/>
                <c:pt idx="0">
                  <c:v>Survival rate %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30133244708047857"/>
                  <c:y val="-0.14615905511811023"/>
                </c:manualLayout>
              </c:layout>
              <c:numFmt formatCode="General" sourceLinked="0"/>
            </c:trendlineLbl>
          </c:trendline>
          <c:xVal>
            <c:numRef>
              <c:f>Sheet3!$AB$2:$AB$153</c:f>
              <c:numCache>
                <c:formatCode>General</c:formatCode>
                <c:ptCount val="152"/>
                <c:pt idx="0">
                  <c:v>0.49110805423574821</c:v>
                </c:pt>
                <c:pt idx="1">
                  <c:v>0.18801127525893052</c:v>
                </c:pt>
                <c:pt idx="2">
                  <c:v>0.49099571066916298</c:v>
                </c:pt>
                <c:pt idx="3">
                  <c:v>0.58901303562213259</c:v>
                </c:pt>
                <c:pt idx="4">
                  <c:v>0.72603021054771533</c:v>
                </c:pt>
                <c:pt idx="5">
                  <c:v>0.71863148740616856</c:v>
                </c:pt>
                <c:pt idx="6">
                  <c:v>0.64867462789023245</c:v>
                </c:pt>
                <c:pt idx="7">
                  <c:v>0.24745218498720614</c:v>
                </c:pt>
                <c:pt idx="8">
                  <c:v>0.59666933294645608</c:v>
                </c:pt>
                <c:pt idx="9">
                  <c:v>0.46178908655589401</c:v>
                </c:pt>
                <c:pt idx="10">
                  <c:v>0.42288152855400418</c:v>
                </c:pt>
                <c:pt idx="11">
                  <c:v>0.32748695804755107</c:v>
                </c:pt>
                <c:pt idx="12">
                  <c:v>0.74442026456725297</c:v>
                </c:pt>
                <c:pt idx="13">
                  <c:v>0.3007226028724746</c:v>
                </c:pt>
                <c:pt idx="14">
                  <c:v>0.54621922544944634</c:v>
                </c:pt>
                <c:pt idx="15">
                  <c:v>0.59333653069387382</c:v>
                </c:pt>
                <c:pt idx="16">
                  <c:v>0.52680336255956628</c:v>
                </c:pt>
                <c:pt idx="17">
                  <c:v>0.58549747095753957</c:v>
                </c:pt>
                <c:pt idx="18">
                  <c:v>0.60880043499761438</c:v>
                </c:pt>
                <c:pt idx="19">
                  <c:v>0.66595101045053295</c:v>
                </c:pt>
                <c:pt idx="20">
                  <c:v>0.46419412891158757</c:v>
                </c:pt>
                <c:pt idx="21">
                  <c:v>0.34921554142785016</c:v>
                </c:pt>
                <c:pt idx="22">
                  <c:v>0.48668666463040056</c:v>
                </c:pt>
                <c:pt idx="23">
                  <c:v>0.4930579418880916</c:v>
                </c:pt>
                <c:pt idx="24">
                  <c:v>0.1639417953069735</c:v>
                </c:pt>
                <c:pt idx="25">
                  <c:v>0.49196622605404433</c:v>
                </c:pt>
                <c:pt idx="26">
                  <c:v>0.40387119150628137</c:v>
                </c:pt>
                <c:pt idx="27">
                  <c:v>0.19467697861790778</c:v>
                </c:pt>
                <c:pt idx="28">
                  <c:v>0.5663529495559344</c:v>
                </c:pt>
                <c:pt idx="29">
                  <c:v>0.60318910493878819</c:v>
                </c:pt>
                <c:pt idx="30">
                  <c:v>0.50809928597365184</c:v>
                </c:pt>
                <c:pt idx="31">
                  <c:v>0.5494790587606756</c:v>
                </c:pt>
                <c:pt idx="32">
                  <c:v>0.38824454860418284</c:v>
                </c:pt>
                <c:pt idx="33">
                  <c:v>0.5472871477644865</c:v>
                </c:pt>
                <c:pt idx="34">
                  <c:v>0.57509489728540075</c:v>
                </c:pt>
                <c:pt idx="35">
                  <c:v>0.53505627984139903</c:v>
                </c:pt>
                <c:pt idx="36">
                  <c:v>0.33274816343047697</c:v>
                </c:pt>
                <c:pt idx="37">
                  <c:v>0.71879016675336072</c:v>
                </c:pt>
                <c:pt idx="38">
                  <c:v>0.47031218654946005</c:v>
                </c:pt>
                <c:pt idx="39">
                  <c:v>0.43255325741883932</c:v>
                </c:pt>
                <c:pt idx="40">
                  <c:v>0.41884574989467982</c:v>
                </c:pt>
                <c:pt idx="41">
                  <c:v>0.47775981641604848</c:v>
                </c:pt>
                <c:pt idx="42">
                  <c:v>0.60569723664439101</c:v>
                </c:pt>
                <c:pt idx="43">
                  <c:v>0.46936446028777645</c:v>
                </c:pt>
                <c:pt idx="44">
                  <c:v>0.51927096632813952</c:v>
                </c:pt>
                <c:pt idx="45">
                  <c:v>0.48631338544396829</c:v>
                </c:pt>
                <c:pt idx="46">
                  <c:v>0.45394048390714364</c:v>
                </c:pt>
                <c:pt idx="47">
                  <c:v>0.31191034671842127</c:v>
                </c:pt>
                <c:pt idx="48">
                  <c:v>0.91318139730510528</c:v>
                </c:pt>
                <c:pt idx="49">
                  <c:v>0.37700774672557735</c:v>
                </c:pt>
                <c:pt idx="50">
                  <c:v>0.59396065114516361</c:v>
                </c:pt>
                <c:pt idx="51">
                  <c:v>0.53072696494811966</c:v>
                </c:pt>
                <c:pt idx="52">
                  <c:v>0.37280254891666137</c:v>
                </c:pt>
                <c:pt idx="53">
                  <c:v>0.32995856169967658</c:v>
                </c:pt>
                <c:pt idx="54">
                  <c:v>0.49247980690953663</c:v>
                </c:pt>
                <c:pt idx="55">
                  <c:v>0.5777533221345349</c:v>
                </c:pt>
                <c:pt idx="56">
                  <c:v>0.5482610592393089</c:v>
                </c:pt>
                <c:pt idx="57">
                  <c:v>0.7273841851171412</c:v>
                </c:pt>
                <c:pt idx="58">
                  <c:v>0.35512573920586199</c:v>
                </c:pt>
                <c:pt idx="59">
                  <c:v>0.41891449829460092</c:v>
                </c:pt>
                <c:pt idx="60">
                  <c:v>0.54230292770935717</c:v>
                </c:pt>
                <c:pt idx="61">
                  <c:v>0.39176870584942647</c:v>
                </c:pt>
                <c:pt idx="62">
                  <c:v>0.78762229917811855</c:v>
                </c:pt>
                <c:pt idx="63">
                  <c:v>0.42808859908179958</c:v>
                </c:pt>
                <c:pt idx="64">
                  <c:v>0.38694457762367562</c:v>
                </c:pt>
                <c:pt idx="65">
                  <c:v>0.18713989382141982</c:v>
                </c:pt>
                <c:pt idx="66">
                  <c:v>0.51781970959310364</c:v>
                </c:pt>
                <c:pt idx="67">
                  <c:v>0.40162573622514441</c:v>
                </c:pt>
                <c:pt idx="68">
                  <c:v>0.35192566441758688</c:v>
                </c:pt>
                <c:pt idx="69">
                  <c:v>0.39194288770244751</c:v>
                </c:pt>
                <c:pt idx="70">
                  <c:v>0.42283391191583247</c:v>
                </c:pt>
                <c:pt idx="71">
                  <c:v>0.33924488946021525</c:v>
                </c:pt>
                <c:pt idx="72">
                  <c:v>0.47036084975919562</c:v>
                </c:pt>
                <c:pt idx="73">
                  <c:v>0.51469025567228877</c:v>
                </c:pt>
                <c:pt idx="74">
                  <c:v>0.56471223689644467</c:v>
                </c:pt>
                <c:pt idx="75">
                  <c:v>0.29427748847369639</c:v>
                </c:pt>
                <c:pt idx="76">
                  <c:v>0.49533021084076745</c:v>
                </c:pt>
                <c:pt idx="77">
                  <c:v>0.48009204291421437</c:v>
                </c:pt>
                <c:pt idx="78">
                  <c:v>0.57482382647258079</c:v>
                </c:pt>
                <c:pt idx="79">
                  <c:v>0.50736994775365873</c:v>
                </c:pt>
                <c:pt idx="80">
                  <c:v>0.56476395553790959</c:v>
                </c:pt>
                <c:pt idx="81">
                  <c:v>1.297770879875421E-2</c:v>
                </c:pt>
                <c:pt idx="82">
                  <c:v>0.74685772389460825</c:v>
                </c:pt>
                <c:pt idx="83">
                  <c:v>0.53072713356212675</c:v>
                </c:pt>
                <c:pt idx="84">
                  <c:v>0.55606341511841306</c:v>
                </c:pt>
                <c:pt idx="85">
                  <c:v>0.32716907310952564</c:v>
                </c:pt>
                <c:pt idx="86">
                  <c:v>0.360408444366008</c:v>
                </c:pt>
                <c:pt idx="87">
                  <c:v>0.8414277305613912</c:v>
                </c:pt>
                <c:pt idx="88">
                  <c:v>0.40665098475018613</c:v>
                </c:pt>
                <c:pt idx="89">
                  <c:v>0.5724230869904342</c:v>
                </c:pt>
                <c:pt idx="90">
                  <c:v>0.43142651343989374</c:v>
                </c:pt>
                <c:pt idx="91">
                  <c:v>0.48096714610875796</c:v>
                </c:pt>
                <c:pt idx="92">
                  <c:v>0.42056331349016196</c:v>
                </c:pt>
                <c:pt idx="93">
                  <c:v>0.36508738169428434</c:v>
                </c:pt>
                <c:pt idx="94">
                  <c:v>0.51375933943208729</c:v>
                </c:pt>
                <c:pt idx="95">
                  <c:v>0.61894022565901652</c:v>
                </c:pt>
                <c:pt idx="96">
                  <c:v>0.45398662791076233</c:v>
                </c:pt>
                <c:pt idx="97">
                  <c:v>0.36506128373027763</c:v>
                </c:pt>
                <c:pt idx="98">
                  <c:v>0.41579480598403767</c:v>
                </c:pt>
                <c:pt idx="99">
                  <c:v>0.936987927408229</c:v>
                </c:pt>
                <c:pt idx="100">
                  <c:v>0.68740333069584125</c:v>
                </c:pt>
                <c:pt idx="101">
                  <c:v>0.48737732261851158</c:v>
                </c:pt>
                <c:pt idx="102">
                  <c:v>0.33222642506424394</c:v>
                </c:pt>
                <c:pt idx="103">
                  <c:v>0.28714636380427783</c:v>
                </c:pt>
                <c:pt idx="104">
                  <c:v>0.47951113708070742</c:v>
                </c:pt>
                <c:pt idx="105">
                  <c:v>0.45848469125251401</c:v>
                </c:pt>
                <c:pt idx="106">
                  <c:v>0.3118027305530669</c:v>
                </c:pt>
                <c:pt idx="107">
                  <c:v>0.57754568733953415</c:v>
                </c:pt>
                <c:pt idx="108">
                  <c:v>0.7933405967928715</c:v>
                </c:pt>
                <c:pt idx="109">
                  <c:v>0.32837457896253486</c:v>
                </c:pt>
                <c:pt idx="110">
                  <c:v>0.35878565301100296</c:v>
                </c:pt>
                <c:pt idx="111">
                  <c:v>0.36430845395971334</c:v>
                </c:pt>
                <c:pt idx="112">
                  <c:v>0.38678100103554092</c:v>
                </c:pt>
                <c:pt idx="113">
                  <c:v>0.56139573901895978</c:v>
                </c:pt>
                <c:pt idx="114">
                  <c:v>0.63826903135742519</c:v>
                </c:pt>
                <c:pt idx="115">
                  <c:v>0.56926352418960646</c:v>
                </c:pt>
                <c:pt idx="116">
                  <c:v>0.18554161256496565</c:v>
                </c:pt>
                <c:pt idx="117">
                  <c:v>0.40555549609098618</c:v>
                </c:pt>
                <c:pt idx="118">
                  <c:v>0.64914683199472378</c:v>
                </c:pt>
                <c:pt idx="119">
                  <c:v>0.53198266746680301</c:v>
                </c:pt>
                <c:pt idx="120">
                  <c:v>0.50862150153489216</c:v>
                </c:pt>
                <c:pt idx="121">
                  <c:v>0.33000759800090074</c:v>
                </c:pt>
                <c:pt idx="122">
                  <c:v>0.16924337603967674</c:v>
                </c:pt>
                <c:pt idx="123">
                  <c:v>0.37511611875682105</c:v>
                </c:pt>
                <c:pt idx="124">
                  <c:v>0.51428341507730724</c:v>
                </c:pt>
                <c:pt idx="125">
                  <c:v>0.27085943241400046</c:v>
                </c:pt>
                <c:pt idx="126">
                  <c:v>0.4932046323286457</c:v>
                </c:pt>
                <c:pt idx="127">
                  <c:v>0.78663716617747736</c:v>
                </c:pt>
                <c:pt idx="128">
                  <c:v>0.45592557293755848</c:v>
                </c:pt>
                <c:pt idx="129">
                  <c:v>0.39741545114441201</c:v>
                </c:pt>
                <c:pt idx="130">
                  <c:v>0.56015509367534033</c:v>
                </c:pt>
                <c:pt idx="131">
                  <c:v>0.42015066402686102</c:v>
                </c:pt>
                <c:pt idx="132">
                  <c:v>0.55900766952646419</c:v>
                </c:pt>
                <c:pt idx="133">
                  <c:v>0.35143201304412003</c:v>
                </c:pt>
                <c:pt idx="134">
                  <c:v>0.78455392078181507</c:v>
                </c:pt>
                <c:pt idx="135">
                  <c:v>0.40432414498232278</c:v>
                </c:pt>
                <c:pt idx="136">
                  <c:v>0.32078745216754634</c:v>
                </c:pt>
                <c:pt idx="137">
                  <c:v>0.58869581880288935</c:v>
                </c:pt>
                <c:pt idx="138">
                  <c:v>0.64844611395085561</c:v>
                </c:pt>
                <c:pt idx="139">
                  <c:v>0.36888528982928026</c:v>
                </c:pt>
                <c:pt idx="140">
                  <c:v>0.54165719221381026</c:v>
                </c:pt>
                <c:pt idx="141">
                  <c:v>0.63459878360225763</c:v>
                </c:pt>
                <c:pt idx="142">
                  <c:v>0.66135982164589013</c:v>
                </c:pt>
                <c:pt idx="143">
                  <c:v>0.4485389545860764</c:v>
                </c:pt>
                <c:pt idx="144">
                  <c:v>0.58058178924211934</c:v>
                </c:pt>
                <c:pt idx="145">
                  <c:v>0.425864884619572</c:v>
                </c:pt>
                <c:pt idx="146">
                  <c:v>0.45276033317891728</c:v>
                </c:pt>
                <c:pt idx="147">
                  <c:v>0.59528844129510794</c:v>
                </c:pt>
                <c:pt idx="148">
                  <c:v>0.48679732476812365</c:v>
                </c:pt>
                <c:pt idx="149">
                  <c:v>4.5268023754566858E-2</c:v>
                </c:pt>
                <c:pt idx="150">
                  <c:v>0.50486894780882752</c:v>
                </c:pt>
                <c:pt idx="151">
                  <c:v>0.26631553873120251</c:v>
                </c:pt>
              </c:numCache>
            </c:numRef>
          </c:xVal>
          <c:yVal>
            <c:numRef>
              <c:f>Sheet3!$AD$2:$AD$153</c:f>
              <c:numCache>
                <c:formatCode>0.0</c:formatCode>
                <c:ptCount val="152"/>
                <c:pt idx="0">
                  <c:v>72.243711510242093</c:v>
                </c:pt>
                <c:pt idx="1">
                  <c:v>48.638591790379301</c:v>
                </c:pt>
                <c:pt idx="2">
                  <c:v>70.682604285560302</c:v>
                </c:pt>
                <c:pt idx="3">
                  <c:v>76.325775319727796</c:v>
                </c:pt>
                <c:pt idx="4">
                  <c:v>75.871038637008795</c:v>
                </c:pt>
                <c:pt idx="5">
                  <c:v>76.6876706968104</c:v>
                </c:pt>
                <c:pt idx="6">
                  <c:v>65.435394944089197</c:v>
                </c:pt>
                <c:pt idx="7">
                  <c:v>49.765079189089199</c:v>
                </c:pt>
                <c:pt idx="8">
                  <c:v>72.288446192521903</c:v>
                </c:pt>
                <c:pt idx="9">
                  <c:v>66.729177921554296</c:v>
                </c:pt>
                <c:pt idx="10">
                  <c:v>73.492358743779903</c:v>
                </c:pt>
                <c:pt idx="11">
                  <c:v>74.846134928717206</c:v>
                </c:pt>
                <c:pt idx="12">
                  <c:v>73.3955656553902</c:v>
                </c:pt>
                <c:pt idx="13">
                  <c:v>63.429335877632298</c:v>
                </c:pt>
                <c:pt idx="14">
                  <c:v>75.253480479777394</c:v>
                </c:pt>
                <c:pt idx="15">
                  <c:v>73.199071882389603</c:v>
                </c:pt>
                <c:pt idx="16">
                  <c:v>72.949493692206303</c:v>
                </c:pt>
                <c:pt idx="17">
                  <c:v>78.188198111091694</c:v>
                </c:pt>
                <c:pt idx="18">
                  <c:v>75.249159099913399</c:v>
                </c:pt>
                <c:pt idx="19">
                  <c:v>82.847539440038901</c:v>
                </c:pt>
                <c:pt idx="20">
                  <c:v>85.887948728075301</c:v>
                </c:pt>
                <c:pt idx="21">
                  <c:v>57.743904352101097</c:v>
                </c:pt>
                <c:pt idx="22">
                  <c:v>53.543183349723598</c:v>
                </c:pt>
                <c:pt idx="23">
                  <c:v>69.068940396842507</c:v>
                </c:pt>
                <c:pt idx="24">
                  <c:v>44.922332524933601</c:v>
                </c:pt>
                <c:pt idx="25">
                  <c:v>76.297625606881198</c:v>
                </c:pt>
                <c:pt idx="26">
                  <c:v>42.695789037185399</c:v>
                </c:pt>
                <c:pt idx="27">
                  <c:v>45.3338763529487</c:v>
                </c:pt>
                <c:pt idx="28">
                  <c:v>82.8083623832798</c:v>
                </c:pt>
                <c:pt idx="29">
                  <c:v>63.983446605205401</c:v>
                </c:pt>
                <c:pt idx="30">
                  <c:v>73.336354026739201</c:v>
                </c:pt>
                <c:pt idx="31">
                  <c:v>76.538023115763494</c:v>
                </c:pt>
                <c:pt idx="32">
                  <c:v>79.876248327143898</c:v>
                </c:pt>
                <c:pt idx="33">
                  <c:v>78.452587939285905</c:v>
                </c:pt>
                <c:pt idx="34">
                  <c:v>73.001655734921997</c:v>
                </c:pt>
                <c:pt idx="35">
                  <c:v>80.524957255004793</c:v>
                </c:pt>
                <c:pt idx="36">
                  <c:v>69.459907926336498</c:v>
                </c:pt>
                <c:pt idx="37">
                  <c:v>50.892813947662702</c:v>
                </c:pt>
                <c:pt idx="38">
                  <c:v>47.170829922562397</c:v>
                </c:pt>
                <c:pt idx="39">
                  <c:v>82.293752315674496</c:v>
                </c:pt>
                <c:pt idx="40">
                  <c:v>57.368296375174801</c:v>
                </c:pt>
                <c:pt idx="41">
                  <c:v>80.836346967221502</c:v>
                </c:pt>
                <c:pt idx="42">
                  <c:v>70.837172482273203</c:v>
                </c:pt>
                <c:pt idx="43">
                  <c:v>68.284256410223904</c:v>
                </c:pt>
                <c:pt idx="44">
                  <c:v>67.635784253372407</c:v>
                </c:pt>
                <c:pt idx="45">
                  <c:v>76.572006118951194</c:v>
                </c:pt>
                <c:pt idx="46">
                  <c:v>75.870614782847298</c:v>
                </c:pt>
                <c:pt idx="47">
                  <c:v>79.388568535382902</c:v>
                </c:pt>
                <c:pt idx="48">
                  <c:v>60.1592496993743</c:v>
                </c:pt>
                <c:pt idx="49">
                  <c:v>68.092038330758896</c:v>
                </c:pt>
                <c:pt idx="50">
                  <c:v>74.485864202258298</c:v>
                </c:pt>
                <c:pt idx="51">
                  <c:v>64.552618500531395</c:v>
                </c:pt>
                <c:pt idx="52">
                  <c:v>77.287389215653803</c:v>
                </c:pt>
                <c:pt idx="53">
                  <c:v>53.245238146497599</c:v>
                </c:pt>
                <c:pt idx="54">
                  <c:v>66.851112001926793</c:v>
                </c:pt>
                <c:pt idx="55">
                  <c:v>84.392577170238198</c:v>
                </c:pt>
                <c:pt idx="56">
                  <c:v>85.430307760159096</c:v>
                </c:pt>
                <c:pt idx="57">
                  <c:v>66.519081041158003</c:v>
                </c:pt>
                <c:pt idx="58">
                  <c:v>52.343454030402903</c:v>
                </c:pt>
                <c:pt idx="59">
                  <c:v>78.826339802448999</c:v>
                </c:pt>
                <c:pt idx="60">
                  <c:v>74.499607962600507</c:v>
                </c:pt>
                <c:pt idx="61">
                  <c:v>73.805324833539302</c:v>
                </c:pt>
                <c:pt idx="62">
                  <c:v>63.507386009074096</c:v>
                </c:pt>
                <c:pt idx="63">
                  <c:v>71.443554875173305</c:v>
                </c:pt>
                <c:pt idx="64">
                  <c:v>64.121790913607597</c:v>
                </c:pt>
                <c:pt idx="65">
                  <c:v>44.2865040110511</c:v>
                </c:pt>
                <c:pt idx="66">
                  <c:v>72.604849242945093</c:v>
                </c:pt>
                <c:pt idx="67">
                  <c:v>65.657990019934701</c:v>
                </c:pt>
                <c:pt idx="68">
                  <c:v>73.559237871061697</c:v>
                </c:pt>
                <c:pt idx="69">
                  <c:v>83.116428950294406</c:v>
                </c:pt>
                <c:pt idx="70">
                  <c:v>70.190893626883494</c:v>
                </c:pt>
                <c:pt idx="71">
                  <c:v>72.929610469459803</c:v>
                </c:pt>
                <c:pt idx="72">
                  <c:v>67.068027132014095</c:v>
                </c:pt>
                <c:pt idx="73">
                  <c:v>69.181890410992196</c:v>
                </c:pt>
                <c:pt idx="74">
                  <c:v>74.676491158996299</c:v>
                </c:pt>
                <c:pt idx="75">
                  <c:v>57.536984909765799</c:v>
                </c:pt>
                <c:pt idx="76">
                  <c:v>65.791849114049796</c:v>
                </c:pt>
                <c:pt idx="77">
                  <c:v>84.914984157936502</c:v>
                </c:pt>
                <c:pt idx="78">
                  <c:v>60.926023278959697</c:v>
                </c:pt>
                <c:pt idx="79">
                  <c:v>67.165587489548997</c:v>
                </c:pt>
                <c:pt idx="80">
                  <c:v>89.150175367181902</c:v>
                </c:pt>
                <c:pt idx="81">
                  <c:v>39.6370981207182</c:v>
                </c:pt>
                <c:pt idx="82">
                  <c:v>75.825647274051903</c:v>
                </c:pt>
                <c:pt idx="83">
                  <c:v>67.657652209611797</c:v>
                </c:pt>
                <c:pt idx="84">
                  <c:v>70.335652607957002</c:v>
                </c:pt>
                <c:pt idx="85">
                  <c:v>73.800673476038298</c:v>
                </c:pt>
                <c:pt idx="86">
                  <c:v>61.363402918741002</c:v>
                </c:pt>
                <c:pt idx="87">
                  <c:v>64.354873965258506</c:v>
                </c:pt>
                <c:pt idx="88">
                  <c:v>59.213071952700901</c:v>
                </c:pt>
                <c:pt idx="89">
                  <c:v>71.343065694413298</c:v>
                </c:pt>
                <c:pt idx="90">
                  <c:v>63.044915574815199</c:v>
                </c:pt>
                <c:pt idx="91">
                  <c:v>66.1704461773611</c:v>
                </c:pt>
                <c:pt idx="92">
                  <c:v>78.5725086846968</c:v>
                </c:pt>
                <c:pt idx="93">
                  <c:v>58.282112520422899</c:v>
                </c:pt>
                <c:pt idx="94">
                  <c:v>62.632787323908097</c:v>
                </c:pt>
                <c:pt idx="95">
                  <c:v>69.947904561833596</c:v>
                </c:pt>
                <c:pt idx="96">
                  <c:v>69.254471918347306</c:v>
                </c:pt>
                <c:pt idx="97">
                  <c:v>58.250192769284197</c:v>
                </c:pt>
                <c:pt idx="98">
                  <c:v>59.436379649633203</c:v>
                </c:pt>
                <c:pt idx="99">
                  <c:v>75.894186025978698</c:v>
                </c:pt>
                <c:pt idx="100">
                  <c:v>66.295865714876996</c:v>
                </c:pt>
                <c:pt idx="101">
                  <c:v>66.256492513127895</c:v>
                </c:pt>
                <c:pt idx="102">
                  <c:v>61.587940449774699</c:v>
                </c:pt>
                <c:pt idx="103">
                  <c:v>65.520450296206107</c:v>
                </c:pt>
                <c:pt idx="104">
                  <c:v>80.400003811475599</c:v>
                </c:pt>
                <c:pt idx="105">
                  <c:v>70.083811193331499</c:v>
                </c:pt>
                <c:pt idx="106">
                  <c:v>54.8158101656838</c:v>
                </c:pt>
                <c:pt idx="107">
                  <c:v>77.025738718287599</c:v>
                </c:pt>
                <c:pt idx="108">
                  <c:v>69.094422651257005</c:v>
                </c:pt>
                <c:pt idx="109">
                  <c:v>50.2485824377314</c:v>
                </c:pt>
                <c:pt idx="110">
                  <c:v>78.1479239587308</c:v>
                </c:pt>
                <c:pt idx="111">
                  <c:v>54.010550364283901</c:v>
                </c:pt>
                <c:pt idx="112">
                  <c:v>76.378501934568703</c:v>
                </c:pt>
                <c:pt idx="113">
                  <c:v>84.796639491771202</c:v>
                </c:pt>
                <c:pt idx="114">
                  <c:v>67.035148148124605</c:v>
                </c:pt>
                <c:pt idx="115">
                  <c:v>71.507875122135701</c:v>
                </c:pt>
                <c:pt idx="116">
                  <c:v>72.130822871744698</c:v>
                </c:pt>
                <c:pt idx="117">
                  <c:v>68.232997213884801</c:v>
                </c:pt>
                <c:pt idx="118">
                  <c:v>63.1216240184174</c:v>
                </c:pt>
                <c:pt idx="119">
                  <c:v>67.018996383619395</c:v>
                </c:pt>
                <c:pt idx="120">
                  <c:v>77.227294924896796</c:v>
                </c:pt>
                <c:pt idx="121">
                  <c:v>72.351578458983795</c:v>
                </c:pt>
                <c:pt idx="122">
                  <c:v>49.084647657325299</c:v>
                </c:pt>
                <c:pt idx="123">
                  <c:v>59.532025617308399</c:v>
                </c:pt>
                <c:pt idx="124">
                  <c:v>86.761064476216305</c:v>
                </c:pt>
                <c:pt idx="125">
                  <c:v>68.418149392532996</c:v>
                </c:pt>
                <c:pt idx="126">
                  <c:v>62.834925658070603</c:v>
                </c:pt>
                <c:pt idx="127">
                  <c:v>75.900116476668202</c:v>
                </c:pt>
                <c:pt idx="128">
                  <c:v>64.300329629942794</c:v>
                </c:pt>
                <c:pt idx="129">
                  <c:v>62.994938678516498</c:v>
                </c:pt>
                <c:pt idx="130">
                  <c:v>72.577220427042604</c:v>
                </c:pt>
                <c:pt idx="131">
                  <c:v>52.681863809230798</c:v>
                </c:pt>
                <c:pt idx="132">
                  <c:v>78.3867509589506</c:v>
                </c:pt>
                <c:pt idx="133">
                  <c:v>70.754563163075602</c:v>
                </c:pt>
                <c:pt idx="134">
                  <c:v>69.855024880704207</c:v>
                </c:pt>
                <c:pt idx="135">
                  <c:v>73.025511985018596</c:v>
                </c:pt>
                <c:pt idx="136">
                  <c:v>71.656204604015898</c:v>
                </c:pt>
                <c:pt idx="137">
                  <c:v>64.359878838273602</c:v>
                </c:pt>
                <c:pt idx="138">
                  <c:v>80.103933291391002</c:v>
                </c:pt>
                <c:pt idx="139">
                  <c:v>81.6958097726055</c:v>
                </c:pt>
                <c:pt idx="140">
                  <c:v>77.760319028668206</c:v>
                </c:pt>
                <c:pt idx="141">
                  <c:v>61.244406374068298</c:v>
                </c:pt>
                <c:pt idx="142">
                  <c:v>69.546445105017398</c:v>
                </c:pt>
                <c:pt idx="143">
                  <c:v>66.066317996215602</c:v>
                </c:pt>
                <c:pt idx="144">
                  <c:v>59.124413998903798</c:v>
                </c:pt>
                <c:pt idx="145">
                  <c:v>76.826197831675103</c:v>
                </c:pt>
                <c:pt idx="146">
                  <c:v>52.0613827464271</c:v>
                </c:pt>
                <c:pt idx="147">
                  <c:v>64.329267214425599</c:v>
                </c:pt>
                <c:pt idx="148">
                  <c:v>62.371207992593</c:v>
                </c:pt>
                <c:pt idx="149">
                  <c:v>1.0689642900515299</c:v>
                </c:pt>
                <c:pt idx="150">
                  <c:v>69.366424522239399</c:v>
                </c:pt>
                <c:pt idx="151">
                  <c:v>55.5624620794787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4906496"/>
        <c:axId val="324907280"/>
      </c:scatterChart>
      <c:scatterChart>
        <c:scatterStyle val="lineMarker"/>
        <c:varyColors val="0"/>
        <c:ser>
          <c:idx val="0"/>
          <c:order val="0"/>
          <c:tx>
            <c:strRef>
              <c:f>Sheet3!$AC$1</c:f>
              <c:strCache>
                <c:ptCount val="1"/>
                <c:pt idx="0">
                  <c:v>PER Stress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39362356879303129"/>
                  <c:y val="5.7706561679790026E-2"/>
                </c:manualLayout>
              </c:layout>
              <c:numFmt formatCode="General" sourceLinked="0"/>
              <c:spPr>
                <a:ln w="3175"/>
              </c:spPr>
            </c:trendlineLbl>
          </c:trendline>
          <c:xVal>
            <c:numRef>
              <c:f>Sheet3!$AB$2:$AB$153</c:f>
              <c:numCache>
                <c:formatCode>General</c:formatCode>
                <c:ptCount val="152"/>
                <c:pt idx="0">
                  <c:v>0.49110805423574821</c:v>
                </c:pt>
                <c:pt idx="1">
                  <c:v>0.18801127525893052</c:v>
                </c:pt>
                <c:pt idx="2">
                  <c:v>0.49099571066916298</c:v>
                </c:pt>
                <c:pt idx="3">
                  <c:v>0.58901303562213259</c:v>
                </c:pt>
                <c:pt idx="4">
                  <c:v>0.72603021054771533</c:v>
                </c:pt>
                <c:pt idx="5">
                  <c:v>0.71863148740616856</c:v>
                </c:pt>
                <c:pt idx="6">
                  <c:v>0.64867462789023245</c:v>
                </c:pt>
                <c:pt idx="7">
                  <c:v>0.24745218498720614</c:v>
                </c:pt>
                <c:pt idx="8">
                  <c:v>0.59666933294645608</c:v>
                </c:pt>
                <c:pt idx="9">
                  <c:v>0.46178908655589401</c:v>
                </c:pt>
                <c:pt idx="10">
                  <c:v>0.42288152855400418</c:v>
                </c:pt>
                <c:pt idx="11">
                  <c:v>0.32748695804755107</c:v>
                </c:pt>
                <c:pt idx="12">
                  <c:v>0.74442026456725297</c:v>
                </c:pt>
                <c:pt idx="13">
                  <c:v>0.3007226028724746</c:v>
                </c:pt>
                <c:pt idx="14">
                  <c:v>0.54621922544944634</c:v>
                </c:pt>
                <c:pt idx="15">
                  <c:v>0.59333653069387382</c:v>
                </c:pt>
                <c:pt idx="16">
                  <c:v>0.52680336255956628</c:v>
                </c:pt>
                <c:pt idx="17">
                  <c:v>0.58549747095753957</c:v>
                </c:pt>
                <c:pt idx="18">
                  <c:v>0.60880043499761438</c:v>
                </c:pt>
                <c:pt idx="19">
                  <c:v>0.66595101045053295</c:v>
                </c:pt>
                <c:pt idx="20">
                  <c:v>0.46419412891158757</c:v>
                </c:pt>
                <c:pt idx="21">
                  <c:v>0.34921554142785016</c:v>
                </c:pt>
                <c:pt idx="22">
                  <c:v>0.48668666463040056</c:v>
                </c:pt>
                <c:pt idx="23">
                  <c:v>0.4930579418880916</c:v>
                </c:pt>
                <c:pt idx="24">
                  <c:v>0.1639417953069735</c:v>
                </c:pt>
                <c:pt idx="25">
                  <c:v>0.49196622605404433</c:v>
                </c:pt>
                <c:pt idx="26">
                  <c:v>0.40387119150628137</c:v>
                </c:pt>
                <c:pt idx="27">
                  <c:v>0.19467697861790778</c:v>
                </c:pt>
                <c:pt idx="28">
                  <c:v>0.5663529495559344</c:v>
                </c:pt>
                <c:pt idx="29">
                  <c:v>0.60318910493878819</c:v>
                </c:pt>
                <c:pt idx="30">
                  <c:v>0.50809928597365184</c:v>
                </c:pt>
                <c:pt idx="31">
                  <c:v>0.5494790587606756</c:v>
                </c:pt>
                <c:pt idx="32">
                  <c:v>0.38824454860418284</c:v>
                </c:pt>
                <c:pt idx="33">
                  <c:v>0.5472871477644865</c:v>
                </c:pt>
                <c:pt idx="34">
                  <c:v>0.57509489728540075</c:v>
                </c:pt>
                <c:pt idx="35">
                  <c:v>0.53505627984139903</c:v>
                </c:pt>
                <c:pt idx="36">
                  <c:v>0.33274816343047697</c:v>
                </c:pt>
                <c:pt idx="37">
                  <c:v>0.71879016675336072</c:v>
                </c:pt>
                <c:pt idx="38">
                  <c:v>0.47031218654946005</c:v>
                </c:pt>
                <c:pt idx="39">
                  <c:v>0.43255325741883932</c:v>
                </c:pt>
                <c:pt idx="40">
                  <c:v>0.41884574989467982</c:v>
                </c:pt>
                <c:pt idx="41">
                  <c:v>0.47775981641604848</c:v>
                </c:pt>
                <c:pt idx="42">
                  <c:v>0.60569723664439101</c:v>
                </c:pt>
                <c:pt idx="43">
                  <c:v>0.46936446028777645</c:v>
                </c:pt>
                <c:pt idx="44">
                  <c:v>0.51927096632813952</c:v>
                </c:pt>
                <c:pt idx="45">
                  <c:v>0.48631338544396829</c:v>
                </c:pt>
                <c:pt idx="46">
                  <c:v>0.45394048390714364</c:v>
                </c:pt>
                <c:pt idx="47">
                  <c:v>0.31191034671842127</c:v>
                </c:pt>
                <c:pt idx="48">
                  <c:v>0.91318139730510528</c:v>
                </c:pt>
                <c:pt idx="49">
                  <c:v>0.37700774672557735</c:v>
                </c:pt>
                <c:pt idx="50">
                  <c:v>0.59396065114516361</c:v>
                </c:pt>
                <c:pt idx="51">
                  <c:v>0.53072696494811966</c:v>
                </c:pt>
                <c:pt idx="52">
                  <c:v>0.37280254891666137</c:v>
                </c:pt>
                <c:pt idx="53">
                  <c:v>0.32995856169967658</c:v>
                </c:pt>
                <c:pt idx="54">
                  <c:v>0.49247980690953663</c:v>
                </c:pt>
                <c:pt idx="55">
                  <c:v>0.5777533221345349</c:v>
                </c:pt>
                <c:pt idx="56">
                  <c:v>0.5482610592393089</c:v>
                </c:pt>
                <c:pt idx="57">
                  <c:v>0.7273841851171412</c:v>
                </c:pt>
                <c:pt idx="58">
                  <c:v>0.35512573920586199</c:v>
                </c:pt>
                <c:pt idx="59">
                  <c:v>0.41891449829460092</c:v>
                </c:pt>
                <c:pt idx="60">
                  <c:v>0.54230292770935717</c:v>
                </c:pt>
                <c:pt idx="61">
                  <c:v>0.39176870584942647</c:v>
                </c:pt>
                <c:pt idx="62">
                  <c:v>0.78762229917811855</c:v>
                </c:pt>
                <c:pt idx="63">
                  <c:v>0.42808859908179958</c:v>
                </c:pt>
                <c:pt idx="64">
                  <c:v>0.38694457762367562</c:v>
                </c:pt>
                <c:pt idx="65">
                  <c:v>0.18713989382141982</c:v>
                </c:pt>
                <c:pt idx="66">
                  <c:v>0.51781970959310364</c:v>
                </c:pt>
                <c:pt idx="67">
                  <c:v>0.40162573622514441</c:v>
                </c:pt>
                <c:pt idx="68">
                  <c:v>0.35192566441758688</c:v>
                </c:pt>
                <c:pt idx="69">
                  <c:v>0.39194288770244751</c:v>
                </c:pt>
                <c:pt idx="70">
                  <c:v>0.42283391191583247</c:v>
                </c:pt>
                <c:pt idx="71">
                  <c:v>0.33924488946021525</c:v>
                </c:pt>
                <c:pt idx="72">
                  <c:v>0.47036084975919562</c:v>
                </c:pt>
                <c:pt idx="73">
                  <c:v>0.51469025567228877</c:v>
                </c:pt>
                <c:pt idx="74">
                  <c:v>0.56471223689644467</c:v>
                </c:pt>
                <c:pt idx="75">
                  <c:v>0.29427748847369639</c:v>
                </c:pt>
                <c:pt idx="76">
                  <c:v>0.49533021084076745</c:v>
                </c:pt>
                <c:pt idx="77">
                  <c:v>0.48009204291421437</c:v>
                </c:pt>
                <c:pt idx="78">
                  <c:v>0.57482382647258079</c:v>
                </c:pt>
                <c:pt idx="79">
                  <c:v>0.50736994775365873</c:v>
                </c:pt>
                <c:pt idx="80">
                  <c:v>0.56476395553790959</c:v>
                </c:pt>
                <c:pt idx="81">
                  <c:v>1.297770879875421E-2</c:v>
                </c:pt>
                <c:pt idx="82">
                  <c:v>0.74685772389460825</c:v>
                </c:pt>
                <c:pt idx="83">
                  <c:v>0.53072713356212675</c:v>
                </c:pt>
                <c:pt idx="84">
                  <c:v>0.55606341511841306</c:v>
                </c:pt>
                <c:pt idx="85">
                  <c:v>0.32716907310952564</c:v>
                </c:pt>
                <c:pt idx="86">
                  <c:v>0.360408444366008</c:v>
                </c:pt>
                <c:pt idx="87">
                  <c:v>0.8414277305613912</c:v>
                </c:pt>
                <c:pt idx="88">
                  <c:v>0.40665098475018613</c:v>
                </c:pt>
                <c:pt idx="89">
                  <c:v>0.5724230869904342</c:v>
                </c:pt>
                <c:pt idx="90">
                  <c:v>0.43142651343989374</c:v>
                </c:pt>
                <c:pt idx="91">
                  <c:v>0.48096714610875796</c:v>
                </c:pt>
                <c:pt idx="92">
                  <c:v>0.42056331349016196</c:v>
                </c:pt>
                <c:pt idx="93">
                  <c:v>0.36508738169428434</c:v>
                </c:pt>
                <c:pt idx="94">
                  <c:v>0.51375933943208729</c:v>
                </c:pt>
                <c:pt idx="95">
                  <c:v>0.61894022565901652</c:v>
                </c:pt>
                <c:pt idx="96">
                  <c:v>0.45398662791076233</c:v>
                </c:pt>
                <c:pt idx="97">
                  <c:v>0.36506128373027763</c:v>
                </c:pt>
                <c:pt idx="98">
                  <c:v>0.41579480598403767</c:v>
                </c:pt>
                <c:pt idx="99">
                  <c:v>0.936987927408229</c:v>
                </c:pt>
                <c:pt idx="100">
                  <c:v>0.68740333069584125</c:v>
                </c:pt>
                <c:pt idx="101">
                  <c:v>0.48737732261851158</c:v>
                </c:pt>
                <c:pt idx="102">
                  <c:v>0.33222642506424394</c:v>
                </c:pt>
                <c:pt idx="103">
                  <c:v>0.28714636380427783</c:v>
                </c:pt>
                <c:pt idx="104">
                  <c:v>0.47951113708070742</c:v>
                </c:pt>
                <c:pt idx="105">
                  <c:v>0.45848469125251401</c:v>
                </c:pt>
                <c:pt idx="106">
                  <c:v>0.3118027305530669</c:v>
                </c:pt>
                <c:pt idx="107">
                  <c:v>0.57754568733953415</c:v>
                </c:pt>
                <c:pt idx="108">
                  <c:v>0.7933405967928715</c:v>
                </c:pt>
                <c:pt idx="109">
                  <c:v>0.32837457896253486</c:v>
                </c:pt>
                <c:pt idx="110">
                  <c:v>0.35878565301100296</c:v>
                </c:pt>
                <c:pt idx="111">
                  <c:v>0.36430845395971334</c:v>
                </c:pt>
                <c:pt idx="112">
                  <c:v>0.38678100103554092</c:v>
                </c:pt>
                <c:pt idx="113">
                  <c:v>0.56139573901895978</c:v>
                </c:pt>
                <c:pt idx="114">
                  <c:v>0.63826903135742519</c:v>
                </c:pt>
                <c:pt idx="115">
                  <c:v>0.56926352418960646</c:v>
                </c:pt>
                <c:pt idx="116">
                  <c:v>0.18554161256496565</c:v>
                </c:pt>
                <c:pt idx="117">
                  <c:v>0.40555549609098618</c:v>
                </c:pt>
                <c:pt idx="118">
                  <c:v>0.64914683199472378</c:v>
                </c:pt>
                <c:pt idx="119">
                  <c:v>0.53198266746680301</c:v>
                </c:pt>
                <c:pt idx="120">
                  <c:v>0.50862150153489216</c:v>
                </c:pt>
                <c:pt idx="121">
                  <c:v>0.33000759800090074</c:v>
                </c:pt>
                <c:pt idx="122">
                  <c:v>0.16924337603967674</c:v>
                </c:pt>
                <c:pt idx="123">
                  <c:v>0.37511611875682105</c:v>
                </c:pt>
                <c:pt idx="124">
                  <c:v>0.51428341507730724</c:v>
                </c:pt>
                <c:pt idx="125">
                  <c:v>0.27085943241400046</c:v>
                </c:pt>
                <c:pt idx="126">
                  <c:v>0.4932046323286457</c:v>
                </c:pt>
                <c:pt idx="127">
                  <c:v>0.78663716617747736</c:v>
                </c:pt>
                <c:pt idx="128">
                  <c:v>0.45592557293755848</c:v>
                </c:pt>
                <c:pt idx="129">
                  <c:v>0.39741545114441201</c:v>
                </c:pt>
                <c:pt idx="130">
                  <c:v>0.56015509367534033</c:v>
                </c:pt>
                <c:pt idx="131">
                  <c:v>0.42015066402686102</c:v>
                </c:pt>
                <c:pt idx="132">
                  <c:v>0.55900766952646419</c:v>
                </c:pt>
                <c:pt idx="133">
                  <c:v>0.35143201304412003</c:v>
                </c:pt>
                <c:pt idx="134">
                  <c:v>0.78455392078181507</c:v>
                </c:pt>
                <c:pt idx="135">
                  <c:v>0.40432414498232278</c:v>
                </c:pt>
                <c:pt idx="136">
                  <c:v>0.32078745216754634</c:v>
                </c:pt>
                <c:pt idx="137">
                  <c:v>0.58869581880288935</c:v>
                </c:pt>
                <c:pt idx="138">
                  <c:v>0.64844611395085561</c:v>
                </c:pt>
                <c:pt idx="139">
                  <c:v>0.36888528982928026</c:v>
                </c:pt>
                <c:pt idx="140">
                  <c:v>0.54165719221381026</c:v>
                </c:pt>
                <c:pt idx="141">
                  <c:v>0.63459878360225763</c:v>
                </c:pt>
                <c:pt idx="142">
                  <c:v>0.66135982164589013</c:v>
                </c:pt>
                <c:pt idx="143">
                  <c:v>0.4485389545860764</c:v>
                </c:pt>
                <c:pt idx="144">
                  <c:v>0.58058178924211934</c:v>
                </c:pt>
                <c:pt idx="145">
                  <c:v>0.425864884619572</c:v>
                </c:pt>
                <c:pt idx="146">
                  <c:v>0.45276033317891728</c:v>
                </c:pt>
                <c:pt idx="147">
                  <c:v>0.59528844129510794</c:v>
                </c:pt>
                <c:pt idx="148">
                  <c:v>0.48679732476812365</c:v>
                </c:pt>
                <c:pt idx="149">
                  <c:v>4.5268023754566858E-2</c:v>
                </c:pt>
                <c:pt idx="150">
                  <c:v>0.50486894780882752</c:v>
                </c:pt>
                <c:pt idx="151">
                  <c:v>0.26631553873120251</c:v>
                </c:pt>
              </c:numCache>
            </c:numRef>
          </c:xVal>
          <c:yVal>
            <c:numRef>
              <c:f>Sheet3!$AC$2:$AC$153</c:f>
              <c:numCache>
                <c:formatCode>General</c:formatCode>
                <c:ptCount val="152"/>
                <c:pt idx="0">
                  <c:v>1.4328384935764</c:v>
                </c:pt>
                <c:pt idx="1">
                  <c:v>1.2149911890798499</c:v>
                </c:pt>
                <c:pt idx="2">
                  <c:v>1.5401770377161299</c:v>
                </c:pt>
                <c:pt idx="3">
                  <c:v>1.3168820301711499</c:v>
                </c:pt>
                <c:pt idx="4">
                  <c:v>1.4227436890002501</c:v>
                </c:pt>
                <c:pt idx="5">
                  <c:v>1.31173679077407</c:v>
                </c:pt>
                <c:pt idx="6">
                  <c:v>1.2721994596878301</c:v>
                </c:pt>
                <c:pt idx="7">
                  <c:v>1.5250261173253901</c:v>
                </c:pt>
                <c:pt idx="8">
                  <c:v>1.4165376321015299</c:v>
                </c:pt>
                <c:pt idx="9">
                  <c:v>1.4926503157900199</c:v>
                </c:pt>
                <c:pt idx="10">
                  <c:v>1.20468832538537</c:v>
                </c:pt>
                <c:pt idx="11">
                  <c:v>1.59080828083542</c:v>
                </c:pt>
                <c:pt idx="12">
                  <c:v>1.38794210304238</c:v>
                </c:pt>
                <c:pt idx="13">
                  <c:v>1.3406134609162501</c:v>
                </c:pt>
                <c:pt idx="14">
                  <c:v>1.5319645227177801</c:v>
                </c:pt>
                <c:pt idx="15">
                  <c:v>1.3729006864348099</c:v>
                </c:pt>
                <c:pt idx="16">
                  <c:v>1.46887684774421</c:v>
                </c:pt>
                <c:pt idx="17">
                  <c:v>1.4149575790303499</c:v>
                </c:pt>
                <c:pt idx="18">
                  <c:v>1.58602068019425</c:v>
                </c:pt>
                <c:pt idx="19">
                  <c:v>1.21845000739666</c:v>
                </c:pt>
                <c:pt idx="20">
                  <c:v>1.33794509466141</c:v>
                </c:pt>
                <c:pt idx="21">
                  <c:v>1.46794506861636</c:v>
                </c:pt>
                <c:pt idx="22">
                  <c:v>1.23119282581392</c:v>
                </c:pt>
                <c:pt idx="23">
                  <c:v>1.5029935873493001</c:v>
                </c:pt>
                <c:pt idx="24">
                  <c:v>0.89453710274154496</c:v>
                </c:pt>
                <c:pt idx="25">
                  <c:v>1.4853720126621399</c:v>
                </c:pt>
                <c:pt idx="26">
                  <c:v>1.49477937068429</c:v>
                </c:pt>
                <c:pt idx="27">
                  <c:v>1.08873907768538</c:v>
                </c:pt>
                <c:pt idx="28">
                  <c:v>1.2988179853322599</c:v>
                </c:pt>
                <c:pt idx="29">
                  <c:v>1.11747244138017</c:v>
                </c:pt>
                <c:pt idx="30">
                  <c:v>1.6450268594956901</c:v>
                </c:pt>
                <c:pt idx="31">
                  <c:v>1.67106574342563</c:v>
                </c:pt>
                <c:pt idx="32">
                  <c:v>1.35248663558228</c:v>
                </c:pt>
                <c:pt idx="33">
                  <c:v>1.4837703745944599</c:v>
                </c:pt>
                <c:pt idx="34">
                  <c:v>1.0729074938468499</c:v>
                </c:pt>
                <c:pt idx="35">
                  <c:v>1.4955598779500201</c:v>
                </c:pt>
                <c:pt idx="36">
                  <c:v>1.31713928718171</c:v>
                </c:pt>
                <c:pt idx="37">
                  <c:v>1.5607893564597199</c:v>
                </c:pt>
                <c:pt idx="38">
                  <c:v>1.32447660384279</c:v>
                </c:pt>
                <c:pt idx="39">
                  <c:v>1.43529540096256</c:v>
                </c:pt>
                <c:pt idx="40">
                  <c:v>1.34118690067327</c:v>
                </c:pt>
                <c:pt idx="41">
                  <c:v>1.5590329335773101</c:v>
                </c:pt>
                <c:pt idx="42">
                  <c:v>1.6279344076784701</c:v>
                </c:pt>
                <c:pt idx="43">
                  <c:v>1.30662886289586</c:v>
                </c:pt>
                <c:pt idx="44">
                  <c:v>1.19126033077899</c:v>
                </c:pt>
                <c:pt idx="45">
                  <c:v>1.38204809866208</c:v>
                </c:pt>
                <c:pt idx="46">
                  <c:v>1.5416248837715401</c:v>
                </c:pt>
                <c:pt idx="47">
                  <c:v>1.3789876363421301</c:v>
                </c:pt>
                <c:pt idx="48">
                  <c:v>1.3079505930352899</c:v>
                </c:pt>
                <c:pt idx="49">
                  <c:v>1.3790316061288399</c:v>
                </c:pt>
                <c:pt idx="50">
                  <c:v>1.1233248245913201</c:v>
                </c:pt>
                <c:pt idx="51">
                  <c:v>1.3895060966884001</c:v>
                </c:pt>
                <c:pt idx="52">
                  <c:v>1.27110757590184</c:v>
                </c:pt>
                <c:pt idx="53">
                  <c:v>1.4638611496810101</c:v>
                </c:pt>
                <c:pt idx="54">
                  <c:v>1.5118340499470999</c:v>
                </c:pt>
                <c:pt idx="55">
                  <c:v>1.64727733418107</c:v>
                </c:pt>
                <c:pt idx="56">
                  <c:v>1.50116862941632</c:v>
                </c:pt>
                <c:pt idx="57">
                  <c:v>1.5051850261328601</c:v>
                </c:pt>
                <c:pt idx="58">
                  <c:v>1.0326823346215599</c:v>
                </c:pt>
                <c:pt idx="59">
                  <c:v>1.50925799312711</c:v>
                </c:pt>
                <c:pt idx="60">
                  <c:v>1.56294958205265</c:v>
                </c:pt>
                <c:pt idx="61">
                  <c:v>1.7202016302134799</c:v>
                </c:pt>
                <c:pt idx="62">
                  <c:v>1.6708783702224801</c:v>
                </c:pt>
                <c:pt idx="63">
                  <c:v>1.5147046049597399</c:v>
                </c:pt>
                <c:pt idx="64">
                  <c:v>1.0738351575090701</c:v>
                </c:pt>
                <c:pt idx="65">
                  <c:v>1.2466075021106999</c:v>
                </c:pt>
                <c:pt idx="66">
                  <c:v>1.5154352513991201</c:v>
                </c:pt>
                <c:pt idx="67">
                  <c:v>1.55182299552535</c:v>
                </c:pt>
                <c:pt idx="68">
                  <c:v>1.31423370537634</c:v>
                </c:pt>
                <c:pt idx="69">
                  <c:v>1.4142001204401899</c:v>
                </c:pt>
                <c:pt idx="70">
                  <c:v>1.08869306098562</c:v>
                </c:pt>
                <c:pt idx="71">
                  <c:v>1.2983498965692899</c:v>
                </c:pt>
                <c:pt idx="72">
                  <c:v>1.35609904968038</c:v>
                </c:pt>
                <c:pt idx="73">
                  <c:v>1.47197920512196</c:v>
                </c:pt>
                <c:pt idx="74">
                  <c:v>1.6566327400247201</c:v>
                </c:pt>
                <c:pt idx="75">
                  <c:v>1.3172935250781399</c:v>
                </c:pt>
                <c:pt idx="76">
                  <c:v>1.1306043822777401</c:v>
                </c:pt>
                <c:pt idx="77">
                  <c:v>1.26569943084806</c:v>
                </c:pt>
                <c:pt idx="78">
                  <c:v>1.3630035306727499</c:v>
                </c:pt>
                <c:pt idx="79">
                  <c:v>1.1881361044367</c:v>
                </c:pt>
                <c:pt idx="80">
                  <c:v>1.48133169567471</c:v>
                </c:pt>
                <c:pt idx="81">
                  <c:v>1.12859673991728</c:v>
                </c:pt>
                <c:pt idx="82">
                  <c:v>1.442220230185</c:v>
                </c:pt>
                <c:pt idx="83">
                  <c:v>1.0975137417274801</c:v>
                </c:pt>
                <c:pt idx="84">
                  <c:v>1.40633797022342</c:v>
                </c:pt>
                <c:pt idx="85">
                  <c:v>1.1795810815207499</c:v>
                </c:pt>
                <c:pt idx="86">
                  <c:v>1.34038762979076</c:v>
                </c:pt>
                <c:pt idx="87">
                  <c:v>1.3606470538039399</c:v>
                </c:pt>
                <c:pt idx="88">
                  <c:v>1.27871928344848</c:v>
                </c:pt>
                <c:pt idx="89">
                  <c:v>1.1293083690740799</c:v>
                </c:pt>
                <c:pt idx="90">
                  <c:v>1.0100830484658501</c:v>
                </c:pt>
                <c:pt idx="91">
                  <c:v>1.118135879502</c:v>
                </c:pt>
                <c:pt idx="92">
                  <c:v>1.3067648625966399</c:v>
                </c:pt>
                <c:pt idx="93">
                  <c:v>1.2190640864398099</c:v>
                </c:pt>
                <c:pt idx="94">
                  <c:v>1.0950201170214799</c:v>
                </c:pt>
                <c:pt idx="95">
                  <c:v>1.5753915626733099</c:v>
                </c:pt>
                <c:pt idx="96">
                  <c:v>1.33246695525762</c:v>
                </c:pt>
                <c:pt idx="97">
                  <c:v>1.03276557904648</c:v>
                </c:pt>
                <c:pt idx="98">
                  <c:v>1.08113472990284</c:v>
                </c:pt>
                <c:pt idx="99">
                  <c:v>1.3713589457528701</c:v>
                </c:pt>
                <c:pt idx="100">
                  <c:v>1.4232876754358299</c:v>
                </c:pt>
                <c:pt idx="101">
                  <c:v>1.34164341792895</c:v>
                </c:pt>
                <c:pt idx="102">
                  <c:v>1.4171923537821201</c:v>
                </c:pt>
                <c:pt idx="103">
                  <c:v>0.82845768290523103</c:v>
                </c:pt>
                <c:pt idx="104">
                  <c:v>1.1244006557580699</c:v>
                </c:pt>
                <c:pt idx="105">
                  <c:v>1.55864401495147</c:v>
                </c:pt>
                <c:pt idx="106">
                  <c:v>0.93475692283315803</c:v>
                </c:pt>
                <c:pt idx="107">
                  <c:v>1.45692040814977</c:v>
                </c:pt>
                <c:pt idx="108">
                  <c:v>1.39263264881527</c:v>
                </c:pt>
                <c:pt idx="109">
                  <c:v>1.2785874735265601</c:v>
                </c:pt>
                <c:pt idx="110">
                  <c:v>1.4571044707288601</c:v>
                </c:pt>
                <c:pt idx="111">
                  <c:v>1.5861079000866301</c:v>
                </c:pt>
                <c:pt idx="112">
                  <c:v>1.7451102145583</c:v>
                </c:pt>
                <c:pt idx="113">
                  <c:v>1.12304866469161</c:v>
                </c:pt>
                <c:pt idx="114">
                  <c:v>1.4774094821724899</c:v>
                </c:pt>
                <c:pt idx="115">
                  <c:v>1.2037789461488999</c:v>
                </c:pt>
                <c:pt idx="116">
                  <c:v>1.09836245547444</c:v>
                </c:pt>
                <c:pt idx="117">
                  <c:v>1.3058836295924201</c:v>
                </c:pt>
                <c:pt idx="118">
                  <c:v>1.1339820529948601</c:v>
                </c:pt>
                <c:pt idx="119">
                  <c:v>1.2222066261448501</c:v>
                </c:pt>
                <c:pt idx="120">
                  <c:v>1.29760588286405</c:v>
                </c:pt>
                <c:pt idx="121">
                  <c:v>1.22476793811235</c:v>
                </c:pt>
                <c:pt idx="122">
                  <c:v>1.5009074020744899</c:v>
                </c:pt>
                <c:pt idx="123">
                  <c:v>1.1471730522046699</c:v>
                </c:pt>
                <c:pt idx="124">
                  <c:v>1.25733627594808</c:v>
                </c:pt>
                <c:pt idx="125">
                  <c:v>0.92679048995862801</c:v>
                </c:pt>
                <c:pt idx="126">
                  <c:v>1.3012250855397101</c:v>
                </c:pt>
                <c:pt idx="127">
                  <c:v>1.27725877051831</c:v>
                </c:pt>
                <c:pt idx="128">
                  <c:v>1.3063745190456499</c:v>
                </c:pt>
                <c:pt idx="129">
                  <c:v>1.4131712865369901</c:v>
                </c:pt>
                <c:pt idx="130">
                  <c:v>1.4353791119713299</c:v>
                </c:pt>
                <c:pt idx="131">
                  <c:v>0.99394854571014601</c:v>
                </c:pt>
                <c:pt idx="132">
                  <c:v>1.30051920389276</c:v>
                </c:pt>
                <c:pt idx="133">
                  <c:v>1.3573925224408401</c:v>
                </c:pt>
                <c:pt idx="134">
                  <c:v>1.49068025609344</c:v>
                </c:pt>
                <c:pt idx="135">
                  <c:v>1.2137870588275601</c:v>
                </c:pt>
                <c:pt idx="136">
                  <c:v>1.53299531753524</c:v>
                </c:pt>
                <c:pt idx="137">
                  <c:v>1.49903602505708</c:v>
                </c:pt>
                <c:pt idx="138">
                  <c:v>1.39035056375088</c:v>
                </c:pt>
                <c:pt idx="139">
                  <c:v>1.3811633189053101</c:v>
                </c:pt>
                <c:pt idx="140">
                  <c:v>1.3849774823024401</c:v>
                </c:pt>
                <c:pt idx="141">
                  <c:v>1.3858010673569401</c:v>
                </c:pt>
                <c:pt idx="142">
                  <c:v>1.40965220406735</c:v>
                </c:pt>
                <c:pt idx="143">
                  <c:v>1.35068037666527</c:v>
                </c:pt>
                <c:pt idx="144">
                  <c:v>1.3405411810235699</c:v>
                </c:pt>
                <c:pt idx="145">
                  <c:v>1.43380203470943</c:v>
                </c:pt>
                <c:pt idx="146">
                  <c:v>1.07628765464799</c:v>
                </c:pt>
                <c:pt idx="147">
                  <c:v>1.55124337524159</c:v>
                </c:pt>
                <c:pt idx="148">
                  <c:v>1.35908226214337</c:v>
                </c:pt>
                <c:pt idx="149">
                  <c:v>0.60284474950839095</c:v>
                </c:pt>
                <c:pt idx="150">
                  <c:v>1.1626415573967599</c:v>
                </c:pt>
                <c:pt idx="151">
                  <c:v>1.231425626186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4909632"/>
        <c:axId val="324909240"/>
      </c:scatterChart>
      <c:valAx>
        <c:axId val="324906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24907280"/>
        <c:crosses val="autoZero"/>
        <c:crossBetween val="midCat"/>
      </c:valAx>
      <c:valAx>
        <c:axId val="324907280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crossAx val="324906496"/>
        <c:crosses val="autoZero"/>
        <c:crossBetween val="midCat"/>
      </c:valAx>
      <c:valAx>
        <c:axId val="324909240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crossAx val="324909632"/>
        <c:crosses val="max"/>
        <c:crossBetween val="midCat"/>
      </c:valAx>
      <c:valAx>
        <c:axId val="3249096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24909240"/>
        <c:crosses val="autoZero"/>
        <c:crossBetween val="midCat"/>
      </c:valAx>
      <c:spPr>
        <a:noFill/>
        <a:ln>
          <a:solidFill>
            <a:schemeClr val="tx1"/>
          </a:solidFill>
        </a:ln>
      </c:spPr>
    </c:plotArea>
    <c:legend>
      <c:legendPos val="r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77922112008726185"/>
          <c:y val="0.7830569553805774"/>
          <c:w val="0.16666632580018406"/>
          <c:h val="0.12055275590551182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2464</cdr:x>
      <cdr:y>0.18</cdr:y>
    </cdr:from>
    <cdr:to>
      <cdr:x>0.81159</cdr:x>
      <cdr:y>0.2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810000" y="685800"/>
          <a:ext cx="457200" cy="228600"/>
        </a:xfrm>
        <a:prstGeom xmlns:a="http://schemas.openxmlformats.org/drawingml/2006/main" prst="rect">
          <a:avLst/>
        </a:prstGeom>
        <a:ln xmlns:a="http://schemas.openxmlformats.org/drawingml/2006/main" w="3175">
          <a:solidFill>
            <a:schemeClr val="tx1"/>
          </a:solidFill>
        </a:ln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 smtClean="0"/>
            <a:t>SER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7971</cdr:x>
      <cdr:y>0.24</cdr:y>
    </cdr:from>
    <cdr:to>
      <cdr:x>0.75362</cdr:x>
      <cdr:y>0.28</cdr:y>
    </cdr:to>
    <cdr:sp macro="" textlink="">
      <cdr:nvSpPr>
        <cdr:cNvPr id="3" name="Curved Up Arrow 2"/>
        <cdr:cNvSpPr/>
      </cdr:nvSpPr>
      <cdr:spPr>
        <a:xfrm xmlns:a="http://schemas.openxmlformats.org/drawingml/2006/main">
          <a:off x="3048000" y="914400"/>
          <a:ext cx="914400" cy="152400"/>
        </a:xfrm>
        <a:prstGeom xmlns:a="http://schemas.openxmlformats.org/drawingml/2006/main" prst="curvedUpArrow">
          <a:avLst/>
        </a:prstGeom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525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821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022272" y="352637"/>
            <a:ext cx="2488407" cy="751691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3562" y="352637"/>
            <a:ext cx="7301071" cy="751691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46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471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698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3562" y="2054648"/>
            <a:ext cx="4894738" cy="5814907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15941" y="2054648"/>
            <a:ext cx="4894739" cy="5814907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177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28" y="1739795"/>
            <a:ext cx="4445953" cy="72506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28" y="2464859"/>
            <a:ext cx="4445953" cy="4478126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174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234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515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1" y="309457"/>
            <a:ext cx="3309144" cy="131699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5" y="309457"/>
            <a:ext cx="5622925" cy="6633528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1" y="1626447"/>
            <a:ext cx="3309144" cy="5316538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529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8"/>
            <a:ext cx="6035040" cy="46634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344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0"/>
            <a:ext cx="9052560" cy="5129425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4"/>
            <a:ext cx="23469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D76FC-CC59-4B95-BB45-C61780F3669A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4"/>
            <a:ext cx="31851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4"/>
            <a:ext cx="23469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E83E9-0D37-4B7D-AF36-4A0E449435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52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824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1018824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1018824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1018824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1018824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24000" y="1411287"/>
            <a:ext cx="6869747" cy="4949825"/>
            <a:chOff x="-144939" y="0"/>
            <a:chExt cx="7079139" cy="5300186"/>
          </a:xfrm>
        </p:grpSpPr>
        <p:grpSp>
          <p:nvGrpSpPr>
            <p:cNvPr id="3" name="Group 2"/>
            <p:cNvGrpSpPr/>
            <p:nvPr/>
          </p:nvGrpSpPr>
          <p:grpSpPr>
            <a:xfrm>
              <a:off x="-144939" y="0"/>
              <a:ext cx="7079139" cy="4391096"/>
              <a:chOff x="-144939" y="0"/>
              <a:chExt cx="7079139" cy="4391096"/>
            </a:xfrm>
          </p:grpSpPr>
          <p:sp>
            <p:nvSpPr>
              <p:cNvPr id="5" name="Bent Arrow 4"/>
              <p:cNvSpPr/>
              <p:nvPr/>
            </p:nvSpPr>
            <p:spPr>
              <a:xfrm>
                <a:off x="4267200" y="984"/>
                <a:ext cx="151831" cy="1049179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100">
                    <a:effectLst/>
                    <a:ea typeface="Times New Roman"/>
                    <a:cs typeface="Times New Roman"/>
                  </a:rPr>
                  <a:t> </a:t>
                </a:r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-144939" y="0"/>
                <a:ext cx="7079139" cy="4391096"/>
                <a:chOff x="-144939" y="0"/>
                <a:chExt cx="7079139" cy="4391096"/>
              </a:xfrm>
            </p:grpSpPr>
            <p:graphicFrame>
              <p:nvGraphicFramePr>
                <p:cNvPr id="7" name="Chart 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59960333"/>
                    </p:ext>
                  </p:extLst>
                </p:nvPr>
              </p:nvGraphicFramePr>
              <p:xfrm>
                <a:off x="1066800" y="285186"/>
                <a:ext cx="5867400" cy="381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8" name="TextBox 3"/>
                <p:cNvSpPr txBox="1"/>
                <p:nvPr/>
              </p:nvSpPr>
              <p:spPr>
                <a:xfrm>
                  <a:off x="4495801" y="0"/>
                  <a:ext cx="384707" cy="240664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kern="1200" dirty="0" smtClean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SR</a:t>
                  </a:r>
                  <a:endParaRPr lang="en-US" sz="1200" dirty="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9" name="TextBox 4"/>
                <p:cNvSpPr txBox="1"/>
                <p:nvPr/>
              </p:nvSpPr>
              <p:spPr>
                <a:xfrm>
                  <a:off x="1675831" y="4095186"/>
                  <a:ext cx="2743200" cy="2959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400" kern="120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Relative yield (SF/Control)</a:t>
                  </a:r>
                  <a:endParaRPr lang="en-U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10" name="TextBox 11"/>
                <p:cNvSpPr txBox="1"/>
                <p:nvPr/>
              </p:nvSpPr>
              <p:spPr>
                <a:xfrm>
                  <a:off x="-144939" y="2177937"/>
                  <a:ext cx="1389379" cy="299083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txBody>
                <a:bodyPr wrap="square" rtlCol="0">
                  <a:no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400" kern="1200" dirty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Survival Rate %</a:t>
                  </a:r>
                  <a:endParaRPr lang="en-US" sz="1200" dirty="0">
                    <a:effectLst/>
                    <a:latin typeface="Times New Roman"/>
                    <a:ea typeface="Times New Roman"/>
                  </a:endParaRPr>
                </a:p>
              </p:txBody>
            </p:sp>
            <p:sp>
              <p:nvSpPr>
                <p:cNvPr id="11" name="TextBox 12"/>
                <p:cNvSpPr txBox="1"/>
                <p:nvPr/>
              </p:nvSpPr>
              <p:spPr>
                <a:xfrm>
                  <a:off x="5000767" y="1935255"/>
                  <a:ext cx="1857375" cy="551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400" kern="1200" dirty="0" smtClean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Shoot </a:t>
                  </a:r>
                  <a:r>
                    <a:rPr lang="en-US" sz="1400" kern="1200" dirty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elongation rate </a:t>
                  </a:r>
                  <a:endParaRPr lang="en-US" sz="1200" dirty="0">
                    <a:effectLst/>
                    <a:latin typeface="Times New Roman"/>
                    <a:ea typeface="Times New Roman"/>
                  </a:endParaRPr>
                </a:p>
                <a:p>
                  <a:pPr marL="0" marR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400" kern="1200" dirty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 in SF (cm day</a:t>
                  </a:r>
                  <a:r>
                    <a:rPr lang="en-US" sz="1400" kern="1200" baseline="30000" dirty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-1</a:t>
                  </a:r>
                  <a:r>
                    <a:rPr lang="en-US" sz="1400" kern="1200" dirty="0">
                      <a:solidFill>
                        <a:srgbClr val="000000"/>
                      </a:solidFill>
                      <a:effectLst/>
                      <a:latin typeface="Times New Roman"/>
                      <a:ea typeface="Times New Roman"/>
                    </a:rPr>
                    <a:t>)</a:t>
                  </a:r>
                  <a:endParaRPr lang="en-US" sz="1200" dirty="0">
                    <a:effectLst/>
                    <a:latin typeface="Times New Roman"/>
                    <a:ea typeface="Times New Roman"/>
                  </a:endParaRPr>
                </a:p>
              </p:txBody>
            </p:sp>
          </p:grpSp>
        </p:grpSp>
        <p:sp>
          <p:nvSpPr>
            <p:cNvPr id="4" name="TextBox 15"/>
            <p:cNvSpPr txBox="1"/>
            <p:nvPr/>
          </p:nvSpPr>
          <p:spPr>
            <a:xfrm>
              <a:off x="1371600" y="4595336"/>
              <a:ext cx="4572000" cy="7048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Supplementary Figure 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3. </a:t>
              </a:r>
              <a:r>
                <a:rPr lang="en-US" sz="1400" kern="1200" dirty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Relationship between </a:t>
              </a:r>
              <a:r>
                <a:rPr lang="en-US" sz="1400" dirty="0" smtClean="0">
                  <a:solidFill>
                    <a:srgbClr val="000000"/>
                  </a:solidFill>
                  <a:latin typeface="Times New Roman"/>
                  <a:ea typeface="Times New Roman"/>
                </a:rPr>
                <a:t>shoot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 </a:t>
              </a:r>
              <a:r>
                <a:rPr lang="en-US" sz="1400" kern="1200" dirty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elongation rate 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(SER</a:t>
              </a:r>
              <a:r>
                <a:rPr lang="en-US" sz="1400" kern="1200" dirty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) under stress SF condition, relative 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grain yield </a:t>
              </a:r>
              <a:r>
                <a:rPr lang="en-US" sz="1400" kern="1200" dirty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(ratio of yield under SF to that in the 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control) </a:t>
              </a:r>
              <a:r>
                <a:rPr lang="en-US" sz="1400" kern="1200" dirty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and survival 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rate (SR</a:t>
              </a:r>
              <a:r>
                <a:rPr lang="en-US" sz="1400" kern="1200" dirty="0" smtClean="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)</a:t>
              </a:r>
              <a:endParaRPr lang="en-US" sz="1400" kern="1200" dirty="0" smtClean="0">
                <a:solidFill>
                  <a:srgbClr val="000000"/>
                </a:solidFill>
                <a:effectLst/>
                <a:latin typeface="Times New Roman"/>
                <a:ea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83750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89</TotalTime>
  <Words>58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shumansingh</dc:creator>
  <cp:lastModifiedBy>Endang Septiningsih</cp:lastModifiedBy>
  <cp:revision>32</cp:revision>
  <dcterms:created xsi:type="dcterms:W3CDTF">2015-09-28T09:55:16Z</dcterms:created>
  <dcterms:modified xsi:type="dcterms:W3CDTF">2016-12-11T15:36:34Z</dcterms:modified>
</cp:coreProperties>
</file>